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64" r:id="rId3"/>
    <p:sldId id="265" r:id="rId4"/>
    <p:sldId id="266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33"/>
    <p:restoredTop sz="94692"/>
  </p:normalViewPr>
  <p:slideViewPr>
    <p:cSldViewPr snapToGrid="0">
      <p:cViewPr varScale="1">
        <p:scale>
          <a:sx n="113" d="100"/>
          <a:sy n="113" d="100"/>
        </p:scale>
        <p:origin x="216" y="1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D69110-E639-46D4-2FB0-F5082E82FE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68F3AB7-6BFF-1773-CECB-D491BFDF9E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EB2273-8E65-0F27-AB08-9D49D35C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7CBA42-7849-A59E-950C-19677E18C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1233F7-F476-A686-A6E1-24914B16C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4750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46605B-4FEF-8E1B-0C66-C488126BBA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ACB1711-006C-5ED6-D92C-D6DBDDCA1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A18268-4AF3-5F89-DEE2-B44EB12B0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B484CD-7DE9-A1C9-364E-A8E2C5B3F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D1CFC3-6B68-811C-ABA4-6D4E9114E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518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6C33244-E214-D1CE-5A69-18CB368EC6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981B43-F04C-EF02-A8EE-D71157D5AE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8119A3-736C-937B-7C29-90824FDB4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7A215C-774C-228B-CAD8-D9A5A8F00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DD77EC-03D6-6C50-3FB5-23BD1D9CB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2122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73EA2E-C71C-ED59-93CF-4B785EFF7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8B9B4D-2523-E961-0A3F-06B991C2CF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9CEA05-A259-F063-5BFE-976E0A880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A7E173-796C-D1B5-D73A-AA06A650C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899227-3AA7-A00B-F322-9634BD9DE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8607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B3603D-F8C5-F71B-D010-DD9DA5ABB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18198C-7DEE-F55B-B98E-8456F07B65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223DFC-6E35-8DD7-7097-ECB92EC8B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8965A5-1B1C-F80A-D7E6-F8A8B48EE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A62341-BF1D-B9EC-6443-6F6611321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95562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28610-F485-F1FC-A3D5-09C1FD51D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601F97-F6FF-71E5-64D3-5190B5C77F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92A0ED-B5BC-3E93-93FB-9A1B9DEB32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3A66F0-0F5C-ABF8-1E16-964120EEC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FF6FEF-3D7F-4B12-BE51-FA978A118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3E8BD9-350F-846B-E94C-466C61FE4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91678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D695F-406D-981F-1B3D-8334AFAC1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24F57BB-FE3D-4A5F-6E42-FCC4E405AA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C32F13-09CA-5847-E5B1-127B75F84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6252365-006F-6570-9DF3-4213B3198B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8C98CB2-F61C-2E2A-5D6A-C78A5F5FD7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E3F32F7-C354-A9E8-FEE5-4CC812583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3B19C07-4F92-7940-E6CA-051DCB45E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7184DEF-7C4B-B391-D3D0-3A4936B35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42941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B692F0-E6CA-A586-8CD6-E7C82C9570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A117ACA-2465-379C-20F0-D345355AF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F4EC85F-57AF-D4C6-A5CF-0D1053696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CCBB1E3-C109-07B8-144A-D85734101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1906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A9A1E3F-BE7A-E17D-A7BE-14E1D6CB7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B838FC9-3E97-2BD4-5951-6EBFC6232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DB9B56E-94D3-AAA7-9072-0834E0C3C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52300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9483BF-DE0D-79B2-0332-208D19FA5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1E14C7-B7DF-138F-DB1D-D8EFF506E9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240A394-7BB2-5B06-90D9-05A8F8E259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5E5615-FCA1-CE80-F1FD-BE017951F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E7CC61-16EA-3A69-8882-71FBC288F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B775BC-F61F-3256-51BF-EF9B757A5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9887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0AD92F-65E6-2F5E-EF32-932FFDCEC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09D518D-276F-E0FF-8EEC-2B6824CF9D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EC42BD-BC05-58B0-8C7A-79DD1D877E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9FABA0-6AEB-AD9B-83B3-4646F8172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2F44D4-FB40-7D7A-0390-4706D5004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86038D-E0BE-99AD-7CEB-FE059DBFE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32230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57DCFB8-00F2-20AB-F1EB-EAA1DE07A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FAA30B-CC5B-4000-06B3-F03FADBACC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5EC75F-0737-0A9A-A5FB-871CD419CE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C8B27E-1E4A-0367-EEA9-4FBB72293E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DF3803-39FD-DBA0-0553-5CD4917CB1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865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EF85793-F7D9-39F9-3F37-53557B51EEFE}"/>
              </a:ext>
            </a:extLst>
          </p:cNvPr>
          <p:cNvSpPr txBox="1"/>
          <p:nvPr/>
        </p:nvSpPr>
        <p:spPr>
          <a:xfrm>
            <a:off x="538571" y="519494"/>
            <a:ext cx="44511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S4</a:t>
            </a:r>
            <a:r>
              <a:rPr kumimoji="1" lang="zh-CN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ubstrate</a:t>
            </a:r>
            <a:r>
              <a:rPr kumimoji="1" lang="zh-CN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oligos</a:t>
            </a:r>
            <a:endParaRPr kumimoji="1"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图形用户界面, 文本&#10;&#10;描述已自动生成">
            <a:extLst>
              <a:ext uri="{FF2B5EF4-FFF2-40B4-BE49-F238E27FC236}">
                <a16:creationId xmlns:a16="http://schemas.microsoft.com/office/drawing/2014/main" id="{B6B2F8FA-574F-577A-1A6B-0C88CFD589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8572" y="1653804"/>
            <a:ext cx="11281935" cy="4022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08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01FC302-CA91-1C03-DAE0-4CC567198759}"/>
              </a:ext>
            </a:extLst>
          </p:cNvPr>
          <p:cNvSpPr txBox="1"/>
          <p:nvPr/>
        </p:nvSpPr>
        <p:spPr>
          <a:xfrm>
            <a:off x="2212201" y="328615"/>
            <a:ext cx="23961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S4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33D37505-B010-BD6A-67B9-EA74B4E3FBDB}"/>
              </a:ext>
            </a:extLst>
          </p:cNvPr>
          <p:cNvGrpSpPr/>
          <p:nvPr/>
        </p:nvGrpSpPr>
        <p:grpSpPr>
          <a:xfrm>
            <a:off x="2212201" y="2081116"/>
            <a:ext cx="920678" cy="3927796"/>
            <a:chOff x="1913206" y="2466981"/>
            <a:chExt cx="920678" cy="3927796"/>
          </a:xfrm>
        </p:grpSpPr>
        <p:sp>
          <p:nvSpPr>
            <p:cNvPr id="21" name="右大括号 20">
              <a:extLst>
                <a:ext uri="{FF2B5EF4-FFF2-40B4-BE49-F238E27FC236}">
                  <a16:creationId xmlns:a16="http://schemas.microsoft.com/office/drawing/2014/main" id="{2FC1D261-1040-CB35-9844-47D2C579249F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B1740248-4AA3-A75B-5FC4-06B39170C1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右大括号 22">
              <a:extLst>
                <a:ext uri="{FF2B5EF4-FFF2-40B4-BE49-F238E27FC236}">
                  <a16:creationId xmlns:a16="http://schemas.microsoft.com/office/drawing/2014/main" id="{75A406D6-EA8D-C442-5C12-179C360C1E05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222483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33A8F66-D8F9-5410-E352-44984977229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0416ADB-A0AB-BB72-82E4-9AE93F1955E5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A3A0E84-E930-3542-9254-6A75C2B5F1C4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" name="图片 7" descr="夜晚的星空&#10;&#10;中度可信度描述已自动生成">
            <a:extLst>
              <a:ext uri="{FF2B5EF4-FFF2-40B4-BE49-F238E27FC236}">
                <a16:creationId xmlns:a16="http://schemas.microsoft.com/office/drawing/2014/main" id="{08DA3742-4455-17B1-84A1-7DBCADFE72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7716" y="1294635"/>
            <a:ext cx="6528647" cy="522291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CE4C50A-B502-9839-0F00-B95DC9CE87BB}"/>
              </a:ext>
            </a:extLst>
          </p:cNvPr>
          <p:cNvSpPr txBox="1"/>
          <p:nvPr/>
        </p:nvSpPr>
        <p:spPr>
          <a:xfrm rot="17974481">
            <a:off x="5664905" y="1714064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523F91E-B8A5-82B2-8142-BA3010B35694}"/>
              </a:ext>
            </a:extLst>
          </p:cNvPr>
          <p:cNvSpPr txBox="1"/>
          <p:nvPr/>
        </p:nvSpPr>
        <p:spPr>
          <a:xfrm rot="17974481">
            <a:off x="5998984" y="171290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3106688-709B-6208-4451-752CD03FECF9}"/>
              </a:ext>
            </a:extLst>
          </p:cNvPr>
          <p:cNvSpPr txBox="1"/>
          <p:nvPr/>
        </p:nvSpPr>
        <p:spPr>
          <a:xfrm rot="17974481">
            <a:off x="6361199" y="171290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758BD40-0B79-1C57-F7FE-520A138E252B}"/>
              </a:ext>
            </a:extLst>
          </p:cNvPr>
          <p:cNvSpPr txBox="1"/>
          <p:nvPr/>
        </p:nvSpPr>
        <p:spPr>
          <a:xfrm rot="17974481">
            <a:off x="6723415" y="171290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8AA3F5D-2978-7DBA-E8A8-F9156F44325F}"/>
              </a:ext>
            </a:extLst>
          </p:cNvPr>
          <p:cNvSpPr txBox="1"/>
          <p:nvPr/>
        </p:nvSpPr>
        <p:spPr>
          <a:xfrm rot="17974481">
            <a:off x="5178008" y="1517630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52E5401-D86E-118A-369B-A8981B543402}"/>
              </a:ext>
            </a:extLst>
          </p:cNvPr>
          <p:cNvSpPr txBox="1"/>
          <p:nvPr/>
        </p:nvSpPr>
        <p:spPr>
          <a:xfrm rot="17974481">
            <a:off x="7063051" y="1712902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3336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33D37505-B010-BD6A-67B9-EA74B4E3FBDB}"/>
              </a:ext>
            </a:extLst>
          </p:cNvPr>
          <p:cNvGrpSpPr/>
          <p:nvPr/>
        </p:nvGrpSpPr>
        <p:grpSpPr>
          <a:xfrm>
            <a:off x="3023038" y="2094951"/>
            <a:ext cx="920678" cy="3826871"/>
            <a:chOff x="1913206" y="2466981"/>
            <a:chExt cx="920678" cy="3826871"/>
          </a:xfrm>
        </p:grpSpPr>
        <p:sp>
          <p:nvSpPr>
            <p:cNvPr id="21" name="右大括号 20">
              <a:extLst>
                <a:ext uri="{FF2B5EF4-FFF2-40B4-BE49-F238E27FC236}">
                  <a16:creationId xmlns:a16="http://schemas.microsoft.com/office/drawing/2014/main" id="{2FC1D261-1040-CB35-9844-47D2C579249F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B1740248-4AA3-A75B-5FC4-06B39170C1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右大括号 22">
              <a:extLst>
                <a:ext uri="{FF2B5EF4-FFF2-40B4-BE49-F238E27FC236}">
                  <a16:creationId xmlns:a16="http://schemas.microsoft.com/office/drawing/2014/main" id="{75A406D6-EA8D-C442-5C12-179C360C1E05}"/>
                </a:ext>
              </a:extLst>
            </p:cNvPr>
            <p:cNvSpPr/>
            <p:nvPr/>
          </p:nvSpPr>
          <p:spPr>
            <a:xfrm flipH="1">
              <a:off x="2587696" y="4169946"/>
              <a:ext cx="239151" cy="2123906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33A8F66-D8F9-5410-E352-44984977229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0416ADB-A0AB-BB72-82E4-9AE93F1955E5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A3A0E84-E930-3542-9254-6A75C2B5F1C4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" name="图片 7" descr="图片包含 电脑, 监控, 照片, 桌子&#10;&#10;描述已自动生成">
            <a:extLst>
              <a:ext uri="{FF2B5EF4-FFF2-40B4-BE49-F238E27FC236}">
                <a16:creationId xmlns:a16="http://schemas.microsoft.com/office/drawing/2014/main" id="{E6450C9D-049B-9BDB-09EC-62FADE61EA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3503" y="1317471"/>
            <a:ext cx="6122408" cy="4897926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16BB878-B9CB-9B4B-8EB1-A2EDCEEF51B5}"/>
              </a:ext>
            </a:extLst>
          </p:cNvPr>
          <p:cNvSpPr txBox="1"/>
          <p:nvPr/>
        </p:nvSpPr>
        <p:spPr>
          <a:xfrm>
            <a:off x="2809142" y="349492"/>
            <a:ext cx="23961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S4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6FCCAAE-A424-64BD-24AF-3AC580F95212}"/>
              </a:ext>
            </a:extLst>
          </p:cNvPr>
          <p:cNvSpPr txBox="1"/>
          <p:nvPr/>
        </p:nvSpPr>
        <p:spPr>
          <a:xfrm rot="17974481">
            <a:off x="5549163" y="1964853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B0462FC-3A78-4B29-B607-0B6827694CBC}"/>
              </a:ext>
            </a:extLst>
          </p:cNvPr>
          <p:cNvSpPr txBox="1"/>
          <p:nvPr/>
        </p:nvSpPr>
        <p:spPr>
          <a:xfrm rot="17974481">
            <a:off x="5871953" y="1963690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7DD1AA0-CEDE-1ECB-0003-32F1A5B6A810}"/>
              </a:ext>
            </a:extLst>
          </p:cNvPr>
          <p:cNvSpPr txBox="1"/>
          <p:nvPr/>
        </p:nvSpPr>
        <p:spPr>
          <a:xfrm rot="17974481">
            <a:off x="6189012" y="1963690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BEAA63E-BC98-173D-CC11-D14FD2C7B269}"/>
              </a:ext>
            </a:extLst>
          </p:cNvPr>
          <p:cNvSpPr txBox="1"/>
          <p:nvPr/>
        </p:nvSpPr>
        <p:spPr>
          <a:xfrm rot="17974481">
            <a:off x="6517361" y="1963690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6B38B54-F582-4F9C-96B6-ED92EE626C58}"/>
              </a:ext>
            </a:extLst>
          </p:cNvPr>
          <p:cNvSpPr txBox="1"/>
          <p:nvPr/>
        </p:nvSpPr>
        <p:spPr>
          <a:xfrm rot="17974481">
            <a:off x="5096133" y="1768419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3334C10-053A-7ED7-7C93-9954660AA4EC}"/>
              </a:ext>
            </a:extLst>
          </p:cNvPr>
          <p:cNvSpPr txBox="1"/>
          <p:nvPr/>
        </p:nvSpPr>
        <p:spPr>
          <a:xfrm rot="17974481">
            <a:off x="6823130" y="196369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7689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33D37505-B010-BD6A-67B9-EA74B4E3FBDB}"/>
              </a:ext>
            </a:extLst>
          </p:cNvPr>
          <p:cNvGrpSpPr/>
          <p:nvPr/>
        </p:nvGrpSpPr>
        <p:grpSpPr>
          <a:xfrm>
            <a:off x="2310337" y="2204300"/>
            <a:ext cx="920678" cy="3909931"/>
            <a:chOff x="1913206" y="2466981"/>
            <a:chExt cx="920678" cy="3909931"/>
          </a:xfrm>
        </p:grpSpPr>
        <p:sp>
          <p:nvSpPr>
            <p:cNvPr id="21" name="右大括号 20">
              <a:extLst>
                <a:ext uri="{FF2B5EF4-FFF2-40B4-BE49-F238E27FC236}">
                  <a16:creationId xmlns:a16="http://schemas.microsoft.com/office/drawing/2014/main" id="{2FC1D261-1040-CB35-9844-47D2C579249F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B1740248-4AA3-A75B-5FC4-06B39170C1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右大括号 22">
              <a:extLst>
                <a:ext uri="{FF2B5EF4-FFF2-40B4-BE49-F238E27FC236}">
                  <a16:creationId xmlns:a16="http://schemas.microsoft.com/office/drawing/2014/main" id="{75A406D6-EA8D-C442-5C12-179C360C1E05}"/>
                </a:ext>
              </a:extLst>
            </p:cNvPr>
            <p:cNvSpPr/>
            <p:nvPr/>
          </p:nvSpPr>
          <p:spPr>
            <a:xfrm flipH="1">
              <a:off x="2587696" y="4169946"/>
              <a:ext cx="239151" cy="2206966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33A8F66-D8F9-5410-E352-44984977229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0416ADB-A0AB-BB72-82E4-9AE93F1955E5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A3A0E84-E930-3542-9254-6A75C2B5F1C4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" name="图片 7" descr="图片包含 监控, 室内, 电脑, 桌子&#10;&#10;描述已自动生成">
            <a:extLst>
              <a:ext uri="{FF2B5EF4-FFF2-40B4-BE49-F238E27FC236}">
                <a16:creationId xmlns:a16="http://schemas.microsoft.com/office/drawing/2014/main" id="{11CA677B-A473-ED6B-17A7-E7E9A9726E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1774" y="1253430"/>
            <a:ext cx="6555883" cy="524470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C8BDA9DD-1080-9ED9-05F1-7BC17BBC09B5}"/>
              </a:ext>
            </a:extLst>
          </p:cNvPr>
          <p:cNvSpPr txBox="1"/>
          <p:nvPr/>
        </p:nvSpPr>
        <p:spPr>
          <a:xfrm rot="17974481">
            <a:off x="5570576" y="202079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AB6A363-530C-0155-75CB-682D1BE015F2}"/>
              </a:ext>
            </a:extLst>
          </p:cNvPr>
          <p:cNvSpPr txBox="1"/>
          <p:nvPr/>
        </p:nvSpPr>
        <p:spPr>
          <a:xfrm rot="17974481">
            <a:off x="5904655" y="201963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0222325-B31F-8D39-C918-6D3D91FE371F}"/>
              </a:ext>
            </a:extLst>
          </p:cNvPr>
          <p:cNvSpPr txBox="1"/>
          <p:nvPr/>
        </p:nvSpPr>
        <p:spPr>
          <a:xfrm rot="17974481">
            <a:off x="6266870" y="201963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0C376E0-E2A0-0709-B00A-C93B8CF0D583}"/>
              </a:ext>
            </a:extLst>
          </p:cNvPr>
          <p:cNvSpPr txBox="1"/>
          <p:nvPr/>
        </p:nvSpPr>
        <p:spPr>
          <a:xfrm rot="17974481">
            <a:off x="6629086" y="201963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6F8A6EE-6CF7-4AF1-DFBE-AF7D97C21C17}"/>
              </a:ext>
            </a:extLst>
          </p:cNvPr>
          <p:cNvSpPr txBox="1"/>
          <p:nvPr/>
        </p:nvSpPr>
        <p:spPr>
          <a:xfrm rot="17974481">
            <a:off x="5072390" y="1824364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5482BDB-DF4B-2938-D0A9-A2724D0D2A1A}"/>
              </a:ext>
            </a:extLst>
          </p:cNvPr>
          <p:cNvSpPr txBox="1"/>
          <p:nvPr/>
        </p:nvSpPr>
        <p:spPr>
          <a:xfrm rot="17974481">
            <a:off x="6991300" y="2019636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1F31C7D-0FD2-A84B-A05C-EE5FF8517EF3}"/>
              </a:ext>
            </a:extLst>
          </p:cNvPr>
          <p:cNvSpPr txBox="1"/>
          <p:nvPr/>
        </p:nvSpPr>
        <p:spPr>
          <a:xfrm>
            <a:off x="2237899" y="299323"/>
            <a:ext cx="23961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S4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714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45</Words>
  <Application>Microsoft Macintosh PowerPoint</Application>
  <PresentationFormat>宽屏</PresentationFormat>
  <Paragraphs>3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16500</dc:creator>
  <cp:keywords/>
  <dc:description/>
  <cp:lastModifiedBy>JDu</cp:lastModifiedBy>
  <cp:revision>25</cp:revision>
  <dcterms:created xsi:type="dcterms:W3CDTF">2025-08-19T01:53:44Z</dcterms:created>
  <dcterms:modified xsi:type="dcterms:W3CDTF">2026-03-06T05:50:49Z</dcterms:modified>
  <cp:category/>
</cp:coreProperties>
</file>